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EF518F-429A-422B-B7BA-7095548B2AA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B44E02-68E8-4094-91B4-7B22C4D0994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0A5873-284F-4007-A99F-303BBA9CC5B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1799CF-8EDD-46A6-8B68-ACC4BAB5B6C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92E3AA-559F-477D-86B8-87D00609BA4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F0AF35-8F5A-44EC-86A4-B16F72A405C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3CBE4C-BB7B-472E-8F62-56AFED8D5D5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DE6A8E-34F0-4A58-B630-BFF076F9C32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487440"/>
            <a:ext cx="5914800" cy="8191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DBA88D-2F34-4032-AD50-74CEBD8829B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4E939F-7B3B-4A59-8161-13731475F9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BA4992-B348-4165-AD84-A5BDC6C8E1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E2DF3F-FD9A-4F27-8720-614F3F1F8D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900" spc="-1" strike="noStrike">
                <a:solidFill>
                  <a:srgbClr val="898989"/>
                </a:solidFill>
                <a:latin typeface="Calibri"/>
                <a:ea typeface="等线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zh-CN" sz="900" spc="-1" strike="noStrike">
                <a:solidFill>
                  <a:srgbClr val="898989"/>
                </a:solidFill>
                <a:latin typeface="Calibri"/>
                <a:ea typeface="等线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8475480"/>
            <a:ext cx="23148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900" spc="-1" strike="noStrike">
                <a:solidFill>
                  <a:srgbClr val="898989"/>
                </a:solidFill>
                <a:latin typeface="Calibri"/>
                <a:ea typeface="等线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F0E50DAE-004F-4D26-994B-944BC99FEAD5}" type="slidenum">
              <a:rPr b="0" lang="zh-CN" sz="900" spc="-1" strike="noStrike">
                <a:solidFill>
                  <a:srgbClr val="898989"/>
                </a:solidFill>
                <a:latin typeface="Calibri"/>
                <a:ea typeface="等线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图片 16" descr=""/>
          <p:cNvPicPr/>
          <p:nvPr/>
        </p:nvPicPr>
        <p:blipFill>
          <a:blip r:embed="rId1"/>
          <a:srcRect l="3516" t="0" r="12532" b="3628"/>
          <a:stretch/>
        </p:blipFill>
        <p:spPr>
          <a:xfrm>
            <a:off x="669960" y="1166760"/>
            <a:ext cx="5037120" cy="5783400"/>
          </a:xfrm>
          <a:prstGeom prst="rect">
            <a:avLst/>
          </a:prstGeom>
          <a:ln w="0">
            <a:noFill/>
          </a:ln>
        </p:spPr>
      </p:pic>
      <p:pic>
        <p:nvPicPr>
          <p:cNvPr id="42" name="图片 17" descr=""/>
          <p:cNvPicPr/>
          <p:nvPr/>
        </p:nvPicPr>
        <p:blipFill>
          <a:blip r:embed="rId2"/>
          <a:srcRect l="89370" t="0" r="1555" b="3628"/>
          <a:stretch/>
        </p:blipFill>
        <p:spPr>
          <a:xfrm>
            <a:off x="5754600" y="1400040"/>
            <a:ext cx="490680" cy="5205600"/>
          </a:xfrm>
          <a:prstGeom prst="rect">
            <a:avLst/>
          </a:prstGeom>
          <a:ln w="0">
            <a:noFill/>
          </a:ln>
        </p:spPr>
      </p:pic>
      <p:sp>
        <p:nvSpPr>
          <p:cNvPr id="43" name="矩形 5"/>
          <p:cNvSpPr/>
          <p:nvPr/>
        </p:nvSpPr>
        <p:spPr>
          <a:xfrm>
            <a:off x="779400" y="7442280"/>
            <a:ext cx="55436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2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Additional file 9: Figure S4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. KEGG analysis of DEGs between the 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OsMBD707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-overexpression line OX707-#21 and wild-type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Rectangle 649"/>
          <p:cNvSpPr/>
          <p:nvPr/>
        </p:nvSpPr>
        <p:spPr>
          <a:xfrm>
            <a:off x="2863800" y="6959520"/>
            <a:ext cx="2795760" cy="119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GeneRatio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9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06-01T05:41:34Z</dcterms:created>
  <dc:creator>csb</dc:creator>
  <dc:description/>
  <dc:language>en-US</dc:language>
  <cp:lastModifiedBy>Admin</cp:lastModifiedBy>
  <cp:lastPrinted>2020-08-14T08:51:54Z</cp:lastPrinted>
  <dcterms:modified xsi:type="dcterms:W3CDTF">2020-12-03T05:54:51Z</dcterms:modified>
  <cp:revision>150</cp:revision>
  <dc:subject/>
  <dc:title>PowerPoint 演示文稿</dc:title>
</cp:coreProperties>
</file>